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9EAD3-B074-4454-9674-4ED021A6DD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481421-5FFC-4E04-81E9-69F6667738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488D5-1E18-4FF8-A731-0877D1F7F5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677DA-0C31-44A4-AC8A-06A73A212D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72717-94FF-4A00-BA7D-B0D1E4861D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68C2BF-DA17-4201-A479-971009238B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B9A31-8EBC-418D-AEA5-6AEE21592B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337E2-E5A4-4589-B10F-D844300E54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B3BF3-C639-4912-BE61-20C242CEB8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F9182-8D76-4BE2-A59E-254C7D7FEE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D1AA0-7EB3-428E-95E7-9BA73489D8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A40607-7AAB-492E-BAF9-5BD5280283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2E7B16-5189-47F1-9F84-B64E9455FA39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95360" y="1033560"/>
          <a:ext cx="11255400" cy="3830400"/>
        </p:xfrm>
        <a:graphic>
          <a:graphicData uri="http://schemas.openxmlformats.org/drawingml/2006/table">
            <a:tbl>
              <a:tblPr/>
              <a:tblGrid>
                <a:gridCol w="1038240"/>
                <a:gridCol w="998640"/>
                <a:gridCol w="954000"/>
                <a:gridCol w="1012680"/>
                <a:gridCol w="998640"/>
                <a:gridCol w="996840"/>
                <a:gridCol w="1381320"/>
                <a:gridCol w="968400"/>
                <a:gridCol w="1042920"/>
                <a:gridCol w="954000"/>
                <a:gridCol w="909720"/>
              </a:tblGrid>
              <a:tr h="412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F  Capetti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 Sterrantino</a:t>
                      </a:r>
                      <a:r>
                        <a:rPr b="0" i="1" lang="it-IT" sz="10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V Cossu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 Orofin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 Barbarin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V De Socio</a:t>
                      </a:r>
                      <a:r>
                        <a:rPr b="0" i="1" lang="it-IT" sz="10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 Di Giambenedett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 Di Biagio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M Celesia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 Argenteri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it-IT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 Rizzardin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1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onceptualiz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Methodolog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sualiz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upervis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vestig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roject Administ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Methodolog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ata Cu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1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Original Draft Prepa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iting – Review &amp;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sualiz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1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Methodolog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alid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Formal Analysi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CasellaDiTesto 5"/>
          <p:cNvSpPr/>
          <p:nvPr/>
        </p:nvSpPr>
        <p:spPr>
          <a:xfrm>
            <a:off x="495360" y="463680"/>
            <a:ext cx="11036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Calibri"/>
              </a:rPr>
              <a:t>Single authors’ contribution to the work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12T22:32:23Z</dcterms:created>
  <dc:creator>Capetti</dc:creator>
  <dc:description/>
  <dc:language>en-US</dc:language>
  <cp:lastModifiedBy>Capetti</cp:lastModifiedBy>
  <dcterms:modified xsi:type="dcterms:W3CDTF">2016-05-12T23:09:56Z</dcterms:modified>
  <cp:revision>6</cp:revision>
  <dc:subject/>
  <dc:title>Presentazione standard di PowerPoint</dc:title>
</cp:coreProperties>
</file>